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jpeg" ContentType="image/jpe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6858000" cy="9144000"/>
  <p:notesSz cx="6983413" cy="9283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984000" cy="9284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3027240" cy="4636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55680" y="0"/>
            <a:ext cx="3027240" cy="4636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87360" y="696960"/>
            <a:ext cx="2609640" cy="3481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2880" rIns="9288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98040" y="4410000"/>
            <a:ext cx="5588280" cy="417672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818560"/>
            <a:ext cx="3027240" cy="4636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55680" y="8818560"/>
            <a:ext cx="3027240" cy="4636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AFC105-7B83-46DD-8AB2-DF03DD0A2F6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hyperlink" Target="file://in-anat-euler/bellidolab/BELLIDO/Yumie%20Rhee/Daily/2008/YR-02-08/ImagePro/YR208-calvariae/JPEG" TargetMode="External"/><Relationship Id="rId2" Type="http://schemas.openxmlformats.org/officeDocument/2006/relationships/slide" Target="../slides/slide2.xml"/><Relationship Id="rId3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sldImg"/>
          </p:nvPr>
        </p:nvSpPr>
        <p:spPr>
          <a:xfrm>
            <a:off x="2187720" y="696960"/>
            <a:ext cx="2609640" cy="3481200"/>
          </a:xfrm>
          <a:prstGeom prst="rect">
            <a:avLst/>
          </a:prstGeom>
          <a:ln w="0">
            <a:noFill/>
          </a:ln>
        </p:spPr>
      </p:sp>
      <p:sp>
        <p:nvSpPr>
          <p:cNvPr id="228" name="PlaceHolder 2"/>
          <p:cNvSpPr>
            <a:spLocks noGrp="1"/>
          </p:cNvSpPr>
          <p:nvPr>
            <p:ph type="body"/>
          </p:nvPr>
        </p:nvSpPr>
        <p:spPr>
          <a:xfrm>
            <a:off x="698040" y="4410000"/>
            <a:ext cx="5588280" cy="417672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7030a0"/>
                </a:solidFill>
                <a:latin typeface="Calibri"/>
              </a:rPr>
              <a:t>Images [A] 81WT[F]/68DLRP%KO/70DMP-J/7Combo </a:t>
            </a:r>
            <a:r>
              <a:rPr b="0" lang="en-US" sz="1200" spc="-1" strike="noStrike" u="sng">
                <a:solidFill>
                  <a:srgbClr val="0000ff"/>
                </a:solidFill>
                <a:uFillTx/>
                <a:latin typeface="Calibri"/>
                <a:hlinkClick r:id="rId1"/>
              </a:rPr>
              <a:t>G:\BELLIDO\Yumie Rhee\Daily\2008\YR-02-08\ImagePro\YR208-calvariae\JPE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7030a0"/>
                </a:solidFill>
                <a:latin typeface="Calibri"/>
              </a:rPr>
              <a:t>[D] 28WT[53-F?]/64DMP-S/41DMP-J/65Combo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:\BELLIDO\Yumie Rhee\Daily\2008\YR-07-08\ImagePro\YR708-calvariae\JPE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7030a0"/>
                </a:solidFill>
                <a:latin typeface="Calibri"/>
              </a:rPr>
              <a:t>Graphs and stats ; [B-C]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:\BELLIDO\Yumie Rhee\Daily\2008\YR-02-08\SigmaPlot\YR208-calvaria-all-042009.JN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7030a0"/>
                </a:solidFill>
                <a:latin typeface="Calibri"/>
              </a:rPr>
              <a:t>[E-F]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:\BELLIDO\Yumie Rhee\Daily\2008\YR-07-08\SigmaPlot\YR708-calvaria-all-041709.JN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7030a0"/>
                </a:solidFill>
                <a:latin typeface="Calibri"/>
              </a:rPr>
              <a:t>C. a, p &lt; 0.05 vs W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7030a0"/>
                </a:solidFill>
                <a:latin typeface="Calibri"/>
              </a:rPr>
              <a:t>b, p &lt; 0.05 vs LRP5 -/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7030a0"/>
                </a:solidFill>
                <a:latin typeface="Calibri"/>
              </a:rPr>
              <a:t>n=4,4,4,3 by 2-way ANOV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7030a0"/>
                </a:solidFill>
                <a:latin typeface="Calibri"/>
              </a:rPr>
              <a:t>E. a, p &lt; 0.05 vs W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7030a0"/>
                </a:solidFill>
                <a:latin typeface="Calibri"/>
              </a:rPr>
              <a:t>b, p &lt; 0.05 vs  DMP-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7030a0"/>
                </a:solidFill>
                <a:latin typeface="Calibri"/>
              </a:rPr>
              <a:t>n=4,4,3,5 by ANOV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Slide Number Placeholder 3"/>
          <p:cNvSpPr/>
          <p:nvPr/>
        </p:nvSpPr>
        <p:spPr>
          <a:xfrm>
            <a:off x="3956040" y="8818560"/>
            <a:ext cx="3027240" cy="4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880" rIns="9288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1B1025-C20F-44B9-8D18-BEE7EDB4BFC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PlaceHolder 1"/>
          <p:cNvSpPr>
            <a:spLocks noGrp="1"/>
          </p:cNvSpPr>
          <p:nvPr>
            <p:ph type="sldImg"/>
          </p:nvPr>
        </p:nvSpPr>
        <p:spPr>
          <a:xfrm>
            <a:off x="2187720" y="696960"/>
            <a:ext cx="2609640" cy="3481200"/>
          </a:xfrm>
          <a:prstGeom prst="rect">
            <a:avLst/>
          </a:prstGeom>
          <a:ln w="0">
            <a:noFill/>
          </a:ln>
        </p:spPr>
      </p:sp>
      <p:sp>
        <p:nvSpPr>
          <p:cNvPr id="231" name="PlaceHolder 2"/>
          <p:cNvSpPr>
            <a:spLocks noGrp="1"/>
          </p:cNvSpPr>
          <p:nvPr>
            <p:ph type="body"/>
          </p:nvPr>
        </p:nvSpPr>
        <p:spPr>
          <a:xfrm>
            <a:off x="698040" y="4410000"/>
            <a:ext cx="5588280" cy="417672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buNone/>
              <a:tabLst>
                <a:tab algn="l" pos="0"/>
                <a:tab algn="l" pos="909720"/>
                <a:tab algn="l" pos="1819440"/>
                <a:tab algn="l" pos="2728800"/>
                <a:tab algn="l" pos="3638520"/>
                <a:tab algn="l" pos="4548240"/>
                <a:tab algn="l" pos="5457960"/>
                <a:tab algn="l" pos="6367320"/>
                <a:tab algn="l" pos="7277040"/>
                <a:tab algn="l" pos="8186760"/>
                <a:tab algn="l" pos="9096480"/>
                <a:tab algn="l" pos="10005840"/>
                <a:tab algn="l" pos="1091556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09720"/>
                <a:tab algn="l" pos="1819440"/>
                <a:tab algn="l" pos="2728800"/>
                <a:tab algn="l" pos="3638520"/>
                <a:tab algn="l" pos="4548240"/>
                <a:tab algn="l" pos="5457960"/>
                <a:tab algn="l" pos="6367320"/>
                <a:tab algn="l" pos="7277040"/>
                <a:tab algn="l" pos="8186760"/>
                <a:tab algn="l" pos="9096480"/>
                <a:tab algn="l" pos="10005840"/>
                <a:tab algn="l" pos="1091556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09720"/>
                <a:tab algn="l" pos="1819440"/>
                <a:tab algn="l" pos="2728800"/>
                <a:tab algn="l" pos="3638520"/>
                <a:tab algn="l" pos="4548240"/>
                <a:tab algn="l" pos="5457960"/>
                <a:tab algn="l" pos="6367320"/>
                <a:tab algn="l" pos="7277040"/>
                <a:tab algn="l" pos="8186760"/>
                <a:tab algn="l" pos="9096480"/>
                <a:tab algn="l" pos="10005840"/>
                <a:tab algn="l" pos="1091556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Slide Number Placeholder 3"/>
          <p:cNvSpPr/>
          <p:nvPr/>
        </p:nvSpPr>
        <p:spPr>
          <a:xfrm>
            <a:off x="3956040" y="8818560"/>
            <a:ext cx="3027240" cy="4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880" rIns="9288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94B26C-C35B-4545-A915-11DA1EA7EF7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563241-5241-4A3D-BAE4-1261760F79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31C855-BDB2-44C6-93D5-29A34178C1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39B3D2-185B-42AC-BBCC-F1B52AF9A0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7CD839-3407-43EA-A4E1-69A08E008A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043F32-A792-47B8-9A62-DAF8E05AA5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C07A61-91E8-406B-92A6-B211CDC0DA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48B7D9-11FB-4049-B763-2D3669D9AA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5EA150-FA5A-4ED9-BD33-E1D1391B8D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62C838-CC1F-4C02-A3E6-86186A82F9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9BB96B-5685-41B2-93E1-9E011AF0B0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E64C8A-42CB-4536-BE76-13AAEBEBD1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A7EACA-F004-4000-85A4-AE378F8189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61FFC5-BD06-4D5E-BC3E-ACDE432FE651}" type="slidenum">
              <a:rPr b="0" lang="en-US" sz="1200" spc="-1" strike="noStrike">
                <a:solidFill>
                  <a:srgbClr val="898989"/>
                </a:solidFill>
                <a:latin typeface="Arial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74"/>
          <p:cNvGrpSpPr/>
          <p:nvPr/>
        </p:nvGrpSpPr>
        <p:grpSpPr>
          <a:xfrm>
            <a:off x="4393800" y="6327360"/>
            <a:ext cx="1301400" cy="1364040"/>
            <a:chOff x="4393800" y="6327360"/>
            <a:chExt cx="1301400" cy="1364040"/>
          </a:xfrm>
        </p:grpSpPr>
        <p:sp>
          <p:nvSpPr>
            <p:cNvPr id="49" name="Rectangle 38"/>
            <p:cNvSpPr/>
            <p:nvPr/>
          </p:nvSpPr>
          <p:spPr>
            <a:xfrm>
              <a:off x="4574520" y="6994440"/>
              <a:ext cx="182520" cy="4500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Line 40"/>
            <p:cNvSpPr/>
            <p:nvPr/>
          </p:nvSpPr>
          <p:spPr>
            <a:xfrm flipV="1">
              <a:off x="4676040" y="6780240"/>
              <a:ext cx="1440" cy="213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Line 41"/>
            <p:cNvSpPr/>
            <p:nvPr/>
          </p:nvSpPr>
          <p:spPr>
            <a:xfrm>
              <a:off x="4647240" y="6780600"/>
              <a:ext cx="58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42"/>
            <p:cNvSpPr/>
            <p:nvPr/>
          </p:nvSpPr>
          <p:spPr>
            <a:xfrm>
              <a:off x="5282280" y="6875280"/>
              <a:ext cx="182520" cy="5688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Freeform 43"/>
            <p:cNvSpPr/>
            <p:nvPr/>
          </p:nvSpPr>
          <p:spPr>
            <a:xfrm flipV="1">
              <a:off x="5282280" y="6875280"/>
              <a:ext cx="182520" cy="568800"/>
            </a:xfrm>
            <a:prstGeom prst="pie">
              <a:avLst/>
            </a:pr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Line 44"/>
            <p:cNvSpPr/>
            <p:nvPr/>
          </p:nvSpPr>
          <p:spPr>
            <a:xfrm flipV="1">
              <a:off x="5385240" y="6327360"/>
              <a:ext cx="1440" cy="547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Line 45"/>
            <p:cNvSpPr/>
            <p:nvPr/>
          </p:nvSpPr>
          <p:spPr>
            <a:xfrm>
              <a:off x="5356800" y="6327720"/>
              <a:ext cx="568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46"/>
            <p:cNvSpPr/>
            <p:nvPr/>
          </p:nvSpPr>
          <p:spPr>
            <a:xfrm>
              <a:off x="4790160" y="7030440"/>
              <a:ext cx="182520" cy="4136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Line 48"/>
            <p:cNvSpPr/>
            <p:nvPr/>
          </p:nvSpPr>
          <p:spPr>
            <a:xfrm flipV="1">
              <a:off x="4891680" y="6875280"/>
              <a:ext cx="1440" cy="154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Line 49"/>
            <p:cNvSpPr/>
            <p:nvPr/>
          </p:nvSpPr>
          <p:spPr>
            <a:xfrm>
              <a:off x="4863240" y="6875280"/>
              <a:ext cx="58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Freeform 51"/>
            <p:cNvSpPr/>
            <p:nvPr/>
          </p:nvSpPr>
          <p:spPr>
            <a:xfrm flipV="1">
              <a:off x="5497920" y="6923520"/>
              <a:ext cx="182520" cy="520560"/>
            </a:xfrm>
            <a:prstGeom prst="pi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Line 52"/>
            <p:cNvSpPr/>
            <p:nvPr/>
          </p:nvSpPr>
          <p:spPr>
            <a:xfrm flipV="1">
              <a:off x="5591520" y="6518520"/>
              <a:ext cx="1440" cy="40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Line 53"/>
            <p:cNvSpPr/>
            <p:nvPr/>
          </p:nvSpPr>
          <p:spPr>
            <a:xfrm>
              <a:off x="5563080" y="6518520"/>
              <a:ext cx="568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13"/>
            <p:cNvSpPr/>
            <p:nvPr/>
          </p:nvSpPr>
          <p:spPr>
            <a:xfrm flipH="1">
              <a:off x="4393440" y="7508520"/>
              <a:ext cx="779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duodenu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Rectangle 14"/>
            <p:cNvSpPr/>
            <p:nvPr/>
          </p:nvSpPr>
          <p:spPr>
            <a:xfrm flipH="1">
              <a:off x="5287680" y="7508520"/>
              <a:ext cx="407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ol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4" name="Group 164"/>
          <p:cNvGrpSpPr/>
          <p:nvPr/>
        </p:nvGrpSpPr>
        <p:grpSpPr>
          <a:xfrm>
            <a:off x="910800" y="5779800"/>
            <a:ext cx="1334880" cy="1911960"/>
            <a:chOff x="910800" y="5779800"/>
            <a:chExt cx="1334880" cy="1911960"/>
          </a:xfrm>
        </p:grpSpPr>
        <p:sp>
          <p:nvSpPr>
            <p:cNvPr id="65" name="Rectangle 93"/>
            <p:cNvSpPr/>
            <p:nvPr/>
          </p:nvSpPr>
          <p:spPr>
            <a:xfrm>
              <a:off x="1094400" y="7054920"/>
              <a:ext cx="182520" cy="3906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Line 95"/>
            <p:cNvSpPr/>
            <p:nvPr/>
          </p:nvSpPr>
          <p:spPr>
            <a:xfrm flipV="1">
              <a:off x="1192320" y="6864480"/>
              <a:ext cx="720" cy="190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Line 96"/>
            <p:cNvSpPr/>
            <p:nvPr/>
          </p:nvSpPr>
          <p:spPr>
            <a:xfrm>
              <a:off x="1165680" y="6864480"/>
              <a:ext cx="5472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Rectangle 97"/>
            <p:cNvSpPr/>
            <p:nvPr/>
          </p:nvSpPr>
          <p:spPr>
            <a:xfrm>
              <a:off x="1831680" y="7102080"/>
              <a:ext cx="182520" cy="3434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Line 99"/>
            <p:cNvSpPr/>
            <p:nvPr/>
          </p:nvSpPr>
          <p:spPr>
            <a:xfrm flipV="1">
              <a:off x="1935000" y="6828120"/>
              <a:ext cx="720" cy="273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Line 100"/>
            <p:cNvSpPr/>
            <p:nvPr/>
          </p:nvSpPr>
          <p:spPr>
            <a:xfrm>
              <a:off x="1907640" y="6828480"/>
              <a:ext cx="5472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Rectangle 103"/>
            <p:cNvSpPr/>
            <p:nvPr/>
          </p:nvSpPr>
          <p:spPr>
            <a:xfrm>
              <a:off x="1320120" y="7018920"/>
              <a:ext cx="182520" cy="4266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Line 105"/>
            <p:cNvSpPr/>
            <p:nvPr/>
          </p:nvSpPr>
          <p:spPr>
            <a:xfrm flipV="1">
              <a:off x="1419480" y="6888240"/>
              <a:ext cx="720" cy="130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Line 106"/>
            <p:cNvSpPr/>
            <p:nvPr/>
          </p:nvSpPr>
          <p:spPr>
            <a:xfrm>
              <a:off x="1392120" y="6888240"/>
              <a:ext cx="5472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Freeform 108"/>
            <p:cNvSpPr/>
            <p:nvPr/>
          </p:nvSpPr>
          <p:spPr>
            <a:xfrm flipV="1">
              <a:off x="2052360" y="6374520"/>
              <a:ext cx="182520" cy="1070280"/>
            </a:xfrm>
            <a:prstGeom prst="pi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Line 109"/>
            <p:cNvSpPr/>
            <p:nvPr/>
          </p:nvSpPr>
          <p:spPr>
            <a:xfrm flipV="1">
              <a:off x="2138760" y="5779800"/>
              <a:ext cx="720" cy="595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Line 110"/>
            <p:cNvSpPr/>
            <p:nvPr/>
          </p:nvSpPr>
          <p:spPr>
            <a:xfrm>
              <a:off x="2111400" y="5780160"/>
              <a:ext cx="5472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Rectangle 13"/>
            <p:cNvSpPr/>
            <p:nvPr/>
          </p:nvSpPr>
          <p:spPr>
            <a:xfrm flipH="1">
              <a:off x="910440" y="7508880"/>
              <a:ext cx="779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duodenu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Rectangle 14"/>
            <p:cNvSpPr/>
            <p:nvPr/>
          </p:nvSpPr>
          <p:spPr>
            <a:xfrm flipH="1">
              <a:off x="1838160" y="7508880"/>
              <a:ext cx="407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ol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9" name="Text Box 5"/>
          <p:cNvSpPr/>
          <p:nvPr/>
        </p:nvSpPr>
        <p:spPr>
          <a:xfrm>
            <a:off x="2036160" y="8721720"/>
            <a:ext cx="278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 Box 19"/>
          <p:cNvSpPr/>
          <p:nvPr/>
        </p:nvSpPr>
        <p:spPr>
          <a:xfrm>
            <a:off x="307440" y="4871880"/>
            <a:ext cx="30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 Box 13"/>
          <p:cNvSpPr/>
          <p:nvPr/>
        </p:nvSpPr>
        <p:spPr>
          <a:xfrm>
            <a:off x="230040" y="38592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 Box 4"/>
          <p:cNvSpPr/>
          <p:nvPr/>
        </p:nvSpPr>
        <p:spPr>
          <a:xfrm>
            <a:off x="3583800" y="37800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38"/>
          <p:cNvSpPr/>
          <p:nvPr/>
        </p:nvSpPr>
        <p:spPr>
          <a:xfrm>
            <a:off x="862200" y="527040"/>
            <a:ext cx="2367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PTH1R TG expression 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MP1-caPTHR1 mi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39"/>
          <p:cNvSpPr/>
          <p:nvPr/>
        </p:nvSpPr>
        <p:spPr>
          <a:xfrm rot="16200000">
            <a:off x="-246600" y="1924560"/>
            <a:ext cx="122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elative m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Line 10"/>
          <p:cNvSpPr/>
          <p:nvPr/>
        </p:nvSpPr>
        <p:spPr>
          <a:xfrm>
            <a:off x="824040" y="3219480"/>
            <a:ext cx="22860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Rectangle 18"/>
          <p:cNvSpPr/>
          <p:nvPr/>
        </p:nvSpPr>
        <p:spPr>
          <a:xfrm flipH="1" rot="16200000">
            <a:off x="903600" y="3415680"/>
            <a:ext cx="365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o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Rectangle 19"/>
          <p:cNvSpPr/>
          <p:nvPr/>
        </p:nvSpPr>
        <p:spPr>
          <a:xfrm flipH="1" rot="16200000">
            <a:off x="789480" y="3798720"/>
            <a:ext cx="1132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keletal musc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Rectangle 20"/>
          <p:cNvSpPr/>
          <p:nvPr/>
        </p:nvSpPr>
        <p:spPr>
          <a:xfrm flipH="1" rot="16200000">
            <a:off x="1461600" y="3418560"/>
            <a:ext cx="374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ear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Rectangle 21"/>
          <p:cNvSpPr/>
          <p:nvPr/>
        </p:nvSpPr>
        <p:spPr>
          <a:xfrm flipH="1" rot="16200000">
            <a:off x="1761480" y="3419280"/>
            <a:ext cx="374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ra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Rectangle 22"/>
          <p:cNvSpPr/>
          <p:nvPr/>
        </p:nvSpPr>
        <p:spPr>
          <a:xfrm flipH="1" rot="16200000">
            <a:off x="2004480" y="3475080"/>
            <a:ext cx="485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idne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Rectangle 23"/>
          <p:cNvSpPr/>
          <p:nvPr/>
        </p:nvSpPr>
        <p:spPr>
          <a:xfrm flipH="1" rot="16200000">
            <a:off x="2116080" y="3625560"/>
            <a:ext cx="779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uodenu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Rectangle 24"/>
          <p:cNvSpPr/>
          <p:nvPr/>
        </p:nvSpPr>
        <p:spPr>
          <a:xfrm flipH="1" rot="16200000">
            <a:off x="2581560" y="3436920"/>
            <a:ext cx="407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l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Line 25"/>
          <p:cNvSpPr/>
          <p:nvPr/>
        </p:nvSpPr>
        <p:spPr>
          <a:xfrm flipV="1">
            <a:off x="824040" y="960120"/>
            <a:ext cx="1440" cy="2259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Line 26"/>
          <p:cNvSpPr/>
          <p:nvPr/>
        </p:nvSpPr>
        <p:spPr>
          <a:xfrm>
            <a:off x="792000" y="3219480"/>
            <a:ext cx="320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Line 27"/>
          <p:cNvSpPr/>
          <p:nvPr/>
        </p:nvSpPr>
        <p:spPr>
          <a:xfrm>
            <a:off x="792000" y="2768760"/>
            <a:ext cx="320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Line 28"/>
          <p:cNvSpPr/>
          <p:nvPr/>
        </p:nvSpPr>
        <p:spPr>
          <a:xfrm>
            <a:off x="792000" y="2316240"/>
            <a:ext cx="320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Line 29"/>
          <p:cNvSpPr/>
          <p:nvPr/>
        </p:nvSpPr>
        <p:spPr>
          <a:xfrm>
            <a:off x="792000" y="1865160"/>
            <a:ext cx="320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Line 30"/>
          <p:cNvSpPr/>
          <p:nvPr/>
        </p:nvSpPr>
        <p:spPr>
          <a:xfrm>
            <a:off x="792000" y="1413000"/>
            <a:ext cx="320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Line 31"/>
          <p:cNvSpPr/>
          <p:nvPr/>
        </p:nvSpPr>
        <p:spPr>
          <a:xfrm>
            <a:off x="792000" y="960480"/>
            <a:ext cx="320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Rectangle 32"/>
          <p:cNvSpPr/>
          <p:nvPr/>
        </p:nvSpPr>
        <p:spPr>
          <a:xfrm>
            <a:off x="660240" y="3137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Rectangle 33"/>
          <p:cNvSpPr/>
          <p:nvPr/>
        </p:nvSpPr>
        <p:spPr>
          <a:xfrm>
            <a:off x="575640" y="26845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Rectangle 34"/>
          <p:cNvSpPr/>
          <p:nvPr/>
        </p:nvSpPr>
        <p:spPr>
          <a:xfrm>
            <a:off x="575640" y="2233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Rectangle 35"/>
          <p:cNvSpPr/>
          <p:nvPr/>
        </p:nvSpPr>
        <p:spPr>
          <a:xfrm>
            <a:off x="575640" y="17812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Rectangle 36"/>
          <p:cNvSpPr/>
          <p:nvPr/>
        </p:nvSpPr>
        <p:spPr>
          <a:xfrm>
            <a:off x="575640" y="13302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Rectangle 37"/>
          <p:cNvSpPr/>
          <p:nvPr/>
        </p:nvSpPr>
        <p:spPr>
          <a:xfrm>
            <a:off x="575640" y="8780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Rectangle 38"/>
          <p:cNvSpPr/>
          <p:nvPr/>
        </p:nvSpPr>
        <p:spPr>
          <a:xfrm>
            <a:off x="995400" y="2162160"/>
            <a:ext cx="183960" cy="10540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Line 40"/>
          <p:cNvSpPr/>
          <p:nvPr/>
        </p:nvSpPr>
        <p:spPr>
          <a:xfrm flipV="1">
            <a:off x="1085760" y="1168560"/>
            <a:ext cx="1800" cy="993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Line 41"/>
          <p:cNvSpPr/>
          <p:nvPr/>
        </p:nvSpPr>
        <p:spPr>
          <a:xfrm>
            <a:off x="1054080" y="1168560"/>
            <a:ext cx="65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Straight Connector 64"/>
          <p:cNvSpPr/>
          <p:nvPr/>
        </p:nvSpPr>
        <p:spPr>
          <a:xfrm>
            <a:off x="1303200" y="3059280"/>
            <a:ext cx="1600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65"/>
          <p:cNvSpPr/>
          <p:nvPr/>
        </p:nvSpPr>
        <p:spPr>
          <a:xfrm>
            <a:off x="1560240" y="2789280"/>
            <a:ext cx="1087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ot detect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Line 81"/>
          <p:cNvSpPr/>
          <p:nvPr/>
        </p:nvSpPr>
        <p:spPr>
          <a:xfrm flipV="1">
            <a:off x="4179960" y="968040"/>
            <a:ext cx="1440" cy="2259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Line 82"/>
          <p:cNvSpPr/>
          <p:nvPr/>
        </p:nvSpPr>
        <p:spPr>
          <a:xfrm>
            <a:off x="4146480" y="3222720"/>
            <a:ext cx="334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Line 83"/>
          <p:cNvSpPr/>
          <p:nvPr/>
        </p:nvSpPr>
        <p:spPr>
          <a:xfrm>
            <a:off x="4146480" y="2776680"/>
            <a:ext cx="334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Line 84"/>
          <p:cNvSpPr/>
          <p:nvPr/>
        </p:nvSpPr>
        <p:spPr>
          <a:xfrm>
            <a:off x="4146480" y="2324160"/>
            <a:ext cx="334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Line 85"/>
          <p:cNvSpPr/>
          <p:nvPr/>
        </p:nvSpPr>
        <p:spPr>
          <a:xfrm>
            <a:off x="4146480" y="1873080"/>
            <a:ext cx="3348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Line 86"/>
          <p:cNvSpPr/>
          <p:nvPr/>
        </p:nvSpPr>
        <p:spPr>
          <a:xfrm>
            <a:off x="4146480" y="1420920"/>
            <a:ext cx="334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Line 87"/>
          <p:cNvSpPr/>
          <p:nvPr/>
        </p:nvSpPr>
        <p:spPr>
          <a:xfrm>
            <a:off x="4146480" y="968400"/>
            <a:ext cx="334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Rectangle 88"/>
          <p:cNvSpPr/>
          <p:nvPr/>
        </p:nvSpPr>
        <p:spPr>
          <a:xfrm>
            <a:off x="4010040" y="31449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Rectangle 89"/>
          <p:cNvSpPr/>
          <p:nvPr/>
        </p:nvSpPr>
        <p:spPr>
          <a:xfrm>
            <a:off x="3881520" y="26924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Rectangle 90"/>
          <p:cNvSpPr/>
          <p:nvPr/>
        </p:nvSpPr>
        <p:spPr>
          <a:xfrm>
            <a:off x="3881520" y="22417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Rectangle 91"/>
          <p:cNvSpPr/>
          <p:nvPr/>
        </p:nvSpPr>
        <p:spPr>
          <a:xfrm>
            <a:off x="3881520" y="17892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Rectangle 92"/>
          <p:cNvSpPr/>
          <p:nvPr/>
        </p:nvSpPr>
        <p:spPr>
          <a:xfrm>
            <a:off x="3881520" y="13381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Rectangle 93"/>
          <p:cNvSpPr/>
          <p:nvPr/>
        </p:nvSpPr>
        <p:spPr>
          <a:xfrm>
            <a:off x="3881520" y="8859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Rectangle 94"/>
          <p:cNvSpPr/>
          <p:nvPr/>
        </p:nvSpPr>
        <p:spPr>
          <a:xfrm>
            <a:off x="4389480" y="1917720"/>
            <a:ext cx="182520" cy="13064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Line 96"/>
          <p:cNvSpPr/>
          <p:nvPr/>
        </p:nvSpPr>
        <p:spPr>
          <a:xfrm flipV="1">
            <a:off x="4479840" y="1293480"/>
            <a:ext cx="1800" cy="623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Line 97"/>
          <p:cNvSpPr/>
          <p:nvPr/>
        </p:nvSpPr>
        <p:spPr>
          <a:xfrm>
            <a:off x="4448160" y="1293840"/>
            <a:ext cx="66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Line 10"/>
          <p:cNvSpPr/>
          <p:nvPr/>
        </p:nvSpPr>
        <p:spPr>
          <a:xfrm>
            <a:off x="4221000" y="3222720"/>
            <a:ext cx="22860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Rectangle 18"/>
          <p:cNvSpPr/>
          <p:nvPr/>
        </p:nvSpPr>
        <p:spPr>
          <a:xfrm flipH="1" rot="16200000">
            <a:off x="4297680" y="3418560"/>
            <a:ext cx="365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o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Rectangle 19"/>
          <p:cNvSpPr/>
          <p:nvPr/>
        </p:nvSpPr>
        <p:spPr>
          <a:xfrm flipH="1" rot="16200000">
            <a:off x="4187160" y="3801600"/>
            <a:ext cx="1132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keletal musc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Rectangle 20"/>
          <p:cNvSpPr/>
          <p:nvPr/>
        </p:nvSpPr>
        <p:spPr>
          <a:xfrm flipH="1" rot="16200000">
            <a:off x="4858200" y="3421440"/>
            <a:ext cx="374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ear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Rectangle 21"/>
          <p:cNvSpPr/>
          <p:nvPr/>
        </p:nvSpPr>
        <p:spPr>
          <a:xfrm flipH="1" rot="16200000">
            <a:off x="5158800" y="3422160"/>
            <a:ext cx="374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ra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Rectangle 22"/>
          <p:cNvSpPr/>
          <p:nvPr/>
        </p:nvSpPr>
        <p:spPr>
          <a:xfrm flipH="1" rot="16200000">
            <a:off x="5401800" y="3477960"/>
            <a:ext cx="485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idne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Rectangle 23"/>
          <p:cNvSpPr/>
          <p:nvPr/>
        </p:nvSpPr>
        <p:spPr>
          <a:xfrm flipH="1" rot="16200000">
            <a:off x="5513400" y="3628080"/>
            <a:ext cx="779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uodenu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Rectangle 24"/>
          <p:cNvSpPr/>
          <p:nvPr/>
        </p:nvSpPr>
        <p:spPr>
          <a:xfrm flipH="1" rot="16200000">
            <a:off x="5978880" y="3439800"/>
            <a:ext cx="407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l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Line 26"/>
          <p:cNvSpPr/>
          <p:nvPr/>
        </p:nvSpPr>
        <p:spPr>
          <a:xfrm>
            <a:off x="4189320" y="3222720"/>
            <a:ext cx="316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Straight Connector 91"/>
          <p:cNvSpPr/>
          <p:nvPr/>
        </p:nvSpPr>
        <p:spPr>
          <a:xfrm>
            <a:off x="4700520" y="3060720"/>
            <a:ext cx="1600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92"/>
          <p:cNvSpPr/>
          <p:nvPr/>
        </p:nvSpPr>
        <p:spPr>
          <a:xfrm>
            <a:off x="4956120" y="2792520"/>
            <a:ext cx="1087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ot detect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Box 93"/>
          <p:cNvSpPr/>
          <p:nvPr/>
        </p:nvSpPr>
        <p:spPr>
          <a:xfrm>
            <a:off x="4376880" y="527040"/>
            <a:ext cx="21711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Sost TG expression 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MP1-Sost mi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94"/>
          <p:cNvSpPr/>
          <p:nvPr/>
        </p:nvSpPr>
        <p:spPr>
          <a:xfrm rot="16200000">
            <a:off x="3107160" y="1924560"/>
            <a:ext cx="122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elative m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Line 15"/>
          <p:cNvSpPr/>
          <p:nvPr/>
        </p:nvSpPr>
        <p:spPr>
          <a:xfrm flipV="1">
            <a:off x="4343400" y="5536800"/>
            <a:ext cx="1440" cy="19018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Line 16"/>
          <p:cNvSpPr/>
          <p:nvPr/>
        </p:nvSpPr>
        <p:spPr>
          <a:xfrm>
            <a:off x="4314960" y="7440480"/>
            <a:ext cx="284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Line 18"/>
          <p:cNvSpPr/>
          <p:nvPr/>
        </p:nvSpPr>
        <p:spPr>
          <a:xfrm>
            <a:off x="4314960" y="6964200"/>
            <a:ext cx="284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Line 20"/>
          <p:cNvSpPr/>
          <p:nvPr/>
        </p:nvSpPr>
        <p:spPr>
          <a:xfrm>
            <a:off x="4314960" y="6488280"/>
            <a:ext cx="284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Line 22"/>
          <p:cNvSpPr/>
          <p:nvPr/>
        </p:nvSpPr>
        <p:spPr>
          <a:xfrm>
            <a:off x="4314960" y="6012000"/>
            <a:ext cx="284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Line 24"/>
          <p:cNvSpPr/>
          <p:nvPr/>
        </p:nvSpPr>
        <p:spPr>
          <a:xfrm>
            <a:off x="4314960" y="5537160"/>
            <a:ext cx="284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Rectangle 25"/>
          <p:cNvSpPr/>
          <p:nvPr/>
        </p:nvSpPr>
        <p:spPr>
          <a:xfrm>
            <a:off x="4177440" y="7327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Rectangle 27"/>
          <p:cNvSpPr/>
          <p:nvPr/>
        </p:nvSpPr>
        <p:spPr>
          <a:xfrm>
            <a:off x="4048920" y="68515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Rectangle 29"/>
          <p:cNvSpPr/>
          <p:nvPr/>
        </p:nvSpPr>
        <p:spPr>
          <a:xfrm>
            <a:off x="4048920" y="63770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Rectangle 31"/>
          <p:cNvSpPr/>
          <p:nvPr/>
        </p:nvSpPr>
        <p:spPr>
          <a:xfrm>
            <a:off x="4048920" y="59022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Rectangle 33"/>
          <p:cNvSpPr/>
          <p:nvPr/>
        </p:nvSpPr>
        <p:spPr>
          <a:xfrm>
            <a:off x="4048920" y="54259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.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1" name="Group 165"/>
          <p:cNvGrpSpPr/>
          <p:nvPr/>
        </p:nvGrpSpPr>
        <p:grpSpPr>
          <a:xfrm>
            <a:off x="5883480" y="7205760"/>
            <a:ext cx="524520" cy="486000"/>
            <a:chOff x="5883480" y="7205760"/>
            <a:chExt cx="524520" cy="486000"/>
          </a:xfrm>
        </p:grpSpPr>
        <p:sp>
          <p:nvSpPr>
            <p:cNvPr id="152" name="Rectangle 34"/>
            <p:cNvSpPr/>
            <p:nvPr/>
          </p:nvSpPr>
          <p:spPr>
            <a:xfrm>
              <a:off x="5883480" y="7328880"/>
              <a:ext cx="183240" cy="1155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Freeform 35"/>
            <p:cNvSpPr/>
            <p:nvPr/>
          </p:nvSpPr>
          <p:spPr>
            <a:xfrm flipV="1">
              <a:off x="5883480" y="7328160"/>
              <a:ext cx="183240" cy="115560"/>
            </a:xfrm>
            <a:prstGeom prst="pie">
              <a:avLst/>
            </a:pr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Line 36"/>
            <p:cNvSpPr/>
            <p:nvPr/>
          </p:nvSpPr>
          <p:spPr>
            <a:xfrm flipV="1">
              <a:off x="5970960" y="7244280"/>
              <a:ext cx="1440" cy="83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Line 37"/>
            <p:cNvSpPr/>
            <p:nvPr/>
          </p:nvSpPr>
          <p:spPr>
            <a:xfrm>
              <a:off x="5942160" y="7244640"/>
              <a:ext cx="572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Rectangle 25"/>
            <p:cNvSpPr/>
            <p:nvPr/>
          </p:nvSpPr>
          <p:spPr>
            <a:xfrm>
              <a:off x="6187680" y="7205760"/>
              <a:ext cx="220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Rectangle 12"/>
            <p:cNvSpPr/>
            <p:nvPr/>
          </p:nvSpPr>
          <p:spPr>
            <a:xfrm flipH="1">
              <a:off x="5883840" y="7508880"/>
              <a:ext cx="365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o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8" name="Line 72"/>
          <p:cNvSpPr/>
          <p:nvPr/>
        </p:nvSpPr>
        <p:spPr>
          <a:xfrm flipV="1">
            <a:off x="905040" y="5540400"/>
            <a:ext cx="1440" cy="1908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Line 73"/>
          <p:cNvSpPr/>
          <p:nvPr/>
        </p:nvSpPr>
        <p:spPr>
          <a:xfrm>
            <a:off x="878040" y="7448400"/>
            <a:ext cx="27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Line 75"/>
          <p:cNvSpPr/>
          <p:nvPr/>
        </p:nvSpPr>
        <p:spPr>
          <a:xfrm>
            <a:off x="878040" y="6970680"/>
            <a:ext cx="2700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Line 77"/>
          <p:cNvSpPr/>
          <p:nvPr/>
        </p:nvSpPr>
        <p:spPr>
          <a:xfrm>
            <a:off x="878040" y="6494400"/>
            <a:ext cx="2700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Line 79"/>
          <p:cNvSpPr/>
          <p:nvPr/>
        </p:nvSpPr>
        <p:spPr>
          <a:xfrm>
            <a:off x="878040" y="6018120"/>
            <a:ext cx="2700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Rectangle 82"/>
          <p:cNvSpPr/>
          <p:nvPr/>
        </p:nvSpPr>
        <p:spPr>
          <a:xfrm>
            <a:off x="743040" y="73296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Rectangle 84"/>
          <p:cNvSpPr/>
          <p:nvPr/>
        </p:nvSpPr>
        <p:spPr>
          <a:xfrm>
            <a:off x="615240" y="68533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Rectangle 86"/>
          <p:cNvSpPr/>
          <p:nvPr/>
        </p:nvSpPr>
        <p:spPr>
          <a:xfrm>
            <a:off x="615240" y="63752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Rectangle 88"/>
          <p:cNvSpPr/>
          <p:nvPr/>
        </p:nvSpPr>
        <p:spPr>
          <a:xfrm>
            <a:off x="615240" y="58993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Rectangle 90"/>
          <p:cNvSpPr/>
          <p:nvPr/>
        </p:nvSpPr>
        <p:spPr>
          <a:xfrm>
            <a:off x="615240" y="54230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.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Line 111"/>
          <p:cNvSpPr/>
          <p:nvPr/>
        </p:nvSpPr>
        <p:spPr>
          <a:xfrm>
            <a:off x="905040" y="7448400"/>
            <a:ext cx="2286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 Box 84"/>
          <p:cNvSpPr/>
          <p:nvPr/>
        </p:nvSpPr>
        <p:spPr>
          <a:xfrm rot="16200000">
            <a:off x="-448200" y="6313680"/>
            <a:ext cx="1780920" cy="23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elative m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0" name="Group 163"/>
          <p:cNvGrpSpPr/>
          <p:nvPr/>
        </p:nvGrpSpPr>
        <p:grpSpPr>
          <a:xfrm>
            <a:off x="2536920" y="7226280"/>
            <a:ext cx="502920" cy="465120"/>
            <a:chOff x="2536920" y="7226280"/>
            <a:chExt cx="502920" cy="465120"/>
          </a:xfrm>
        </p:grpSpPr>
        <p:sp>
          <p:nvSpPr>
            <p:cNvPr id="171" name="Freeform 92"/>
            <p:cNvSpPr/>
            <p:nvPr/>
          </p:nvSpPr>
          <p:spPr>
            <a:xfrm flipV="1">
              <a:off x="2536920" y="7412400"/>
              <a:ext cx="182520" cy="33120"/>
            </a:xfrm>
            <a:prstGeom prst="pie">
              <a:avLst/>
            </a:pr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Rectangle 12"/>
            <p:cNvSpPr/>
            <p:nvPr/>
          </p:nvSpPr>
          <p:spPr>
            <a:xfrm flipH="1">
              <a:off x="2552040" y="7508520"/>
              <a:ext cx="365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o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Rectangle 25"/>
            <p:cNvSpPr/>
            <p:nvPr/>
          </p:nvSpPr>
          <p:spPr>
            <a:xfrm>
              <a:off x="2819520" y="7226280"/>
              <a:ext cx="220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74" name="Line 54"/>
          <p:cNvSpPr/>
          <p:nvPr/>
        </p:nvSpPr>
        <p:spPr>
          <a:xfrm>
            <a:off x="4343400" y="7442280"/>
            <a:ext cx="22860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Text Box 84"/>
          <p:cNvSpPr/>
          <p:nvPr/>
        </p:nvSpPr>
        <p:spPr>
          <a:xfrm rot="16200000">
            <a:off x="2956680" y="6314400"/>
            <a:ext cx="1828800" cy="23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elative m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Line 81"/>
          <p:cNvSpPr/>
          <p:nvPr/>
        </p:nvSpPr>
        <p:spPr>
          <a:xfrm>
            <a:off x="878040" y="5540400"/>
            <a:ext cx="270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7" name="Group 176"/>
          <p:cNvGrpSpPr/>
          <p:nvPr/>
        </p:nvGrpSpPr>
        <p:grpSpPr>
          <a:xfrm>
            <a:off x="1066680" y="5207040"/>
            <a:ext cx="1711440" cy="502200"/>
            <a:chOff x="1066680" y="5207040"/>
            <a:chExt cx="1711440" cy="502200"/>
          </a:xfrm>
        </p:grpSpPr>
        <p:sp>
          <p:nvSpPr>
            <p:cNvPr id="178" name="Rectangle 273"/>
            <p:cNvSpPr/>
            <p:nvPr/>
          </p:nvSpPr>
          <p:spPr>
            <a:xfrm>
              <a:off x="1066680" y="5321160"/>
              <a:ext cx="257760" cy="79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Rectangle 274"/>
            <p:cNvSpPr/>
            <p:nvPr/>
          </p:nvSpPr>
          <p:spPr>
            <a:xfrm>
              <a:off x="1066680" y="5541840"/>
              <a:ext cx="257760" cy="79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Text Box 275"/>
            <p:cNvSpPr/>
            <p:nvPr/>
          </p:nvSpPr>
          <p:spPr>
            <a:xfrm>
              <a:off x="1298880" y="520704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Text Box 276"/>
            <p:cNvSpPr/>
            <p:nvPr/>
          </p:nvSpPr>
          <p:spPr>
            <a:xfrm>
              <a:off x="1146600" y="5432760"/>
              <a:ext cx="1631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P1-caPTHR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82" name="Group 178"/>
          <p:cNvGrpSpPr/>
          <p:nvPr/>
        </p:nvGrpSpPr>
        <p:grpSpPr>
          <a:xfrm>
            <a:off x="4521240" y="5207040"/>
            <a:ext cx="1857240" cy="502200"/>
            <a:chOff x="4521240" y="5207040"/>
            <a:chExt cx="1857240" cy="502200"/>
          </a:xfrm>
        </p:grpSpPr>
        <p:sp>
          <p:nvSpPr>
            <p:cNvPr id="183" name="Text Box 276"/>
            <p:cNvSpPr/>
            <p:nvPr/>
          </p:nvSpPr>
          <p:spPr>
            <a:xfrm>
              <a:off x="4745880" y="5432760"/>
              <a:ext cx="1632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P1-Sos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84" name="Group 177"/>
            <p:cNvGrpSpPr/>
            <p:nvPr/>
          </p:nvGrpSpPr>
          <p:grpSpPr>
            <a:xfrm>
              <a:off x="4521240" y="5207040"/>
              <a:ext cx="649440" cy="414360"/>
              <a:chOff x="4521240" y="5207040"/>
              <a:chExt cx="649440" cy="414360"/>
            </a:xfrm>
          </p:grpSpPr>
          <p:sp>
            <p:nvSpPr>
              <p:cNvPr id="185" name="Rectangle 273"/>
              <p:cNvSpPr/>
              <p:nvPr/>
            </p:nvSpPr>
            <p:spPr>
              <a:xfrm>
                <a:off x="4521240" y="5321160"/>
                <a:ext cx="258120" cy="792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" name="Rectangle 274"/>
              <p:cNvSpPr/>
              <p:nvPr/>
            </p:nvSpPr>
            <p:spPr>
              <a:xfrm>
                <a:off x="4521240" y="5542200"/>
                <a:ext cx="258120" cy="7920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" name="Text Box 275"/>
              <p:cNvSpPr/>
              <p:nvPr/>
            </p:nvSpPr>
            <p:spPr>
              <a:xfrm>
                <a:off x="4753800" y="5207040"/>
                <a:ext cx="416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WT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88" name="Text Box 275"/>
          <p:cNvSpPr/>
          <p:nvPr/>
        </p:nvSpPr>
        <p:spPr>
          <a:xfrm>
            <a:off x="2633760" y="4978440"/>
            <a:ext cx="1595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ph1 expres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Text Box 5"/>
          <p:cNvSpPr/>
          <p:nvPr/>
        </p:nvSpPr>
        <p:spPr>
          <a:xfrm>
            <a:off x="2036160" y="8721720"/>
            <a:ext cx="278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Text Box 4"/>
          <p:cNvSpPr/>
          <p:nvPr/>
        </p:nvSpPr>
        <p:spPr>
          <a:xfrm>
            <a:off x="310680" y="874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Text Box 13"/>
          <p:cNvSpPr/>
          <p:nvPr/>
        </p:nvSpPr>
        <p:spPr>
          <a:xfrm>
            <a:off x="309960" y="38257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Rectangle 250"/>
          <p:cNvSpPr/>
          <p:nvPr/>
        </p:nvSpPr>
        <p:spPr>
          <a:xfrm>
            <a:off x="3755880" y="220680"/>
            <a:ext cx="2284560" cy="3505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3" name="Picture 251" descr="28-WT.jpg"/>
          <p:cNvPicPr/>
          <p:nvPr/>
        </p:nvPicPr>
        <p:blipFill>
          <a:blip r:embed="rId1"/>
          <a:srcRect l="17775" t="16494" r="21114" b="30854"/>
          <a:stretch/>
        </p:blipFill>
        <p:spPr>
          <a:xfrm rot="300000">
            <a:off x="3985920" y="396720"/>
            <a:ext cx="1914480" cy="695520"/>
          </a:xfrm>
          <a:prstGeom prst="rect">
            <a:avLst/>
          </a:prstGeom>
          <a:ln w="0">
            <a:noFill/>
          </a:ln>
        </p:spPr>
      </p:pic>
      <p:pic>
        <p:nvPicPr>
          <p:cNvPr id="194" name="Picture 255" descr="64-DMP-S.jpg"/>
          <p:cNvPicPr/>
          <p:nvPr/>
        </p:nvPicPr>
        <p:blipFill>
          <a:blip r:embed="rId2"/>
          <a:srcRect l="33282" t="14639" r="9082" b="47609"/>
          <a:stretch/>
        </p:blipFill>
        <p:spPr>
          <a:xfrm>
            <a:off x="3855960" y="2125800"/>
            <a:ext cx="2070000" cy="503280"/>
          </a:xfrm>
          <a:prstGeom prst="rect">
            <a:avLst/>
          </a:prstGeom>
          <a:ln w="0">
            <a:noFill/>
          </a:ln>
        </p:spPr>
      </p:pic>
      <p:pic>
        <p:nvPicPr>
          <p:cNvPr id="195" name="Picture 259" descr="41-DMP-J.jpg"/>
          <p:cNvPicPr/>
          <p:nvPr/>
        </p:nvPicPr>
        <p:blipFill>
          <a:blip r:embed="rId3"/>
          <a:srcRect l="20005" t="8518" r="0" b="5328"/>
          <a:stretch/>
        </p:blipFill>
        <p:spPr>
          <a:xfrm>
            <a:off x="3956040" y="1325520"/>
            <a:ext cx="1908360" cy="649440"/>
          </a:xfrm>
          <a:prstGeom prst="rect">
            <a:avLst/>
          </a:prstGeom>
          <a:ln w="0">
            <a:noFill/>
          </a:ln>
        </p:spPr>
      </p:pic>
      <p:sp>
        <p:nvSpPr>
          <p:cNvPr id="196" name="Text Box 2"/>
          <p:cNvSpPr/>
          <p:nvPr/>
        </p:nvSpPr>
        <p:spPr>
          <a:xfrm>
            <a:off x="3820680" y="1897200"/>
            <a:ext cx="985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DMP1-Sos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Text Box 3"/>
          <p:cNvSpPr/>
          <p:nvPr/>
        </p:nvSpPr>
        <p:spPr>
          <a:xfrm>
            <a:off x="3818880" y="297000"/>
            <a:ext cx="41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Text Box 2"/>
          <p:cNvSpPr/>
          <p:nvPr/>
        </p:nvSpPr>
        <p:spPr>
          <a:xfrm>
            <a:off x="3820680" y="1036800"/>
            <a:ext cx="132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DMP1-caPTHR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9" name="Picture 263" descr="52-combo.jpg"/>
          <p:cNvPicPr/>
          <p:nvPr/>
        </p:nvPicPr>
        <p:blipFill>
          <a:blip r:embed="rId4"/>
          <a:srcRect l="13336" t="10370" r="0" b="10370"/>
          <a:stretch/>
        </p:blipFill>
        <p:spPr>
          <a:xfrm>
            <a:off x="3908520" y="3040200"/>
            <a:ext cx="1931760" cy="593640"/>
          </a:xfrm>
          <a:prstGeom prst="rect">
            <a:avLst/>
          </a:prstGeom>
          <a:ln w="0">
            <a:noFill/>
          </a:ln>
        </p:spPr>
      </p:pic>
      <p:sp>
        <p:nvSpPr>
          <p:cNvPr id="200" name="Text Box 2"/>
          <p:cNvSpPr/>
          <p:nvPr/>
        </p:nvSpPr>
        <p:spPr>
          <a:xfrm>
            <a:off x="3823920" y="2716200"/>
            <a:ext cx="222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DMP1-caPTHR1; DMP1-Sos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Rectangle 307"/>
          <p:cNvSpPr/>
          <p:nvPr/>
        </p:nvSpPr>
        <p:spPr>
          <a:xfrm>
            <a:off x="1216080" y="220680"/>
            <a:ext cx="2286000" cy="35020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2" name="Picture 308" descr="81-WT.jpg"/>
          <p:cNvPicPr/>
          <p:nvPr/>
        </p:nvPicPr>
        <p:blipFill>
          <a:blip r:embed="rId5"/>
          <a:srcRect l="13885" t="0" r="0" b="23127"/>
          <a:stretch/>
        </p:blipFill>
        <p:spPr>
          <a:xfrm>
            <a:off x="1360440" y="392040"/>
            <a:ext cx="1989360" cy="522360"/>
          </a:xfrm>
          <a:prstGeom prst="rect">
            <a:avLst/>
          </a:prstGeom>
          <a:ln w="0">
            <a:noFill/>
          </a:ln>
        </p:spPr>
      </p:pic>
      <p:pic>
        <p:nvPicPr>
          <p:cNvPr id="203" name="Picture 309" descr="68-Lrp5KO.jpg"/>
          <p:cNvPicPr/>
          <p:nvPr/>
        </p:nvPicPr>
        <p:blipFill>
          <a:blip r:embed="rId6"/>
          <a:srcRect l="17677" t="0" r="0" b="42178"/>
          <a:stretch/>
        </p:blipFill>
        <p:spPr>
          <a:xfrm>
            <a:off x="1392120" y="2004840"/>
            <a:ext cx="2024280" cy="520920"/>
          </a:xfrm>
          <a:prstGeom prst="rect">
            <a:avLst/>
          </a:prstGeom>
          <a:ln w="0">
            <a:noFill/>
          </a:ln>
        </p:spPr>
      </p:pic>
      <p:pic>
        <p:nvPicPr>
          <p:cNvPr id="204" name="Picture 310" descr="70-DMP-J.jpg"/>
          <p:cNvPicPr/>
          <p:nvPr/>
        </p:nvPicPr>
        <p:blipFill>
          <a:blip r:embed="rId7"/>
          <a:srcRect l="0" t="0" r="0" b="28700"/>
          <a:stretch/>
        </p:blipFill>
        <p:spPr>
          <a:xfrm>
            <a:off x="1392120" y="1135080"/>
            <a:ext cx="2006640" cy="603360"/>
          </a:xfrm>
          <a:prstGeom prst="rect">
            <a:avLst/>
          </a:prstGeom>
          <a:ln w="0">
            <a:noFill/>
          </a:ln>
        </p:spPr>
      </p:pic>
      <p:pic>
        <p:nvPicPr>
          <p:cNvPr id="205" name="Picture 311" descr="7-Combo.jpg"/>
          <p:cNvPicPr/>
          <p:nvPr/>
        </p:nvPicPr>
        <p:blipFill>
          <a:blip r:embed="rId8"/>
          <a:srcRect l="0" t="0" r="0" b="17903"/>
          <a:stretch/>
        </p:blipFill>
        <p:spPr>
          <a:xfrm>
            <a:off x="1330200" y="2887560"/>
            <a:ext cx="2005200" cy="703440"/>
          </a:xfrm>
          <a:prstGeom prst="rect">
            <a:avLst/>
          </a:prstGeom>
          <a:ln w="0">
            <a:noFill/>
          </a:ln>
        </p:spPr>
      </p:pic>
      <p:sp>
        <p:nvSpPr>
          <p:cNvPr id="206" name="Text Box 2"/>
          <p:cNvSpPr/>
          <p:nvPr/>
        </p:nvSpPr>
        <p:spPr>
          <a:xfrm>
            <a:off x="1311480" y="1897200"/>
            <a:ext cx="75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LRP5 -/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Text Box 3"/>
          <p:cNvSpPr/>
          <p:nvPr/>
        </p:nvSpPr>
        <p:spPr>
          <a:xfrm>
            <a:off x="1310760" y="297000"/>
            <a:ext cx="41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Text Box 2"/>
          <p:cNvSpPr/>
          <p:nvPr/>
        </p:nvSpPr>
        <p:spPr>
          <a:xfrm>
            <a:off x="1312200" y="1036800"/>
            <a:ext cx="132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DMP1-caPTHR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Text Box 2"/>
          <p:cNvSpPr/>
          <p:nvPr/>
        </p:nvSpPr>
        <p:spPr>
          <a:xfrm>
            <a:off x="1306440" y="2716200"/>
            <a:ext cx="208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DMP1-caPTHR1; LRP5 -/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10" name=""/>
          <p:cNvGraphicFramePr/>
          <p:nvPr/>
        </p:nvGraphicFramePr>
        <p:xfrm>
          <a:off x="380880" y="4011480"/>
          <a:ext cx="6019920" cy="824040"/>
        </p:xfrm>
        <a:graphic>
          <a:graphicData uri="http://schemas.openxmlformats.org/drawingml/2006/table">
            <a:tbl>
              <a:tblPr/>
              <a:tblGrid>
                <a:gridCol w="1919520"/>
                <a:gridCol w="927000"/>
                <a:gridCol w="1109520"/>
                <a:gridCol w="901800"/>
                <a:gridCol w="1162080"/>
              </a:tblGrid>
              <a:tr h="3502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MP1-caPTHR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LRP5-/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MP1-caPTHR1; LRP5-/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68760" rIns="68760" tIns="0" bIns="0" anchor="b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spcBef>
                          <a:spcPts val="476"/>
                        </a:spcBef>
                        <a:tabLst>
                          <a:tab algn="l" pos="0"/>
                          <a:tab algn="l" pos="2286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alvaria thickness (</a:t>
                      </a: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μ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0.57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.7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9.43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8.98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3.67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.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38.47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2.76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75320">
                <a:tc>
                  <a:txBody>
                    <a:bodyPr lIns="68760" rIns="68760" tIns="0" bIns="0" anchor="b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eriosteal BFR/BS (µm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/µm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/d)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0</a:t>
                      </a: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9</a:t>
                      </a: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0</a:t>
                      </a: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2</a:t>
                      </a: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211" name=""/>
          <p:cNvGraphicFramePr/>
          <p:nvPr/>
        </p:nvGraphicFramePr>
        <p:xfrm>
          <a:off x="390600" y="5186520"/>
          <a:ext cx="6010200" cy="841320"/>
        </p:xfrm>
        <a:graphic>
          <a:graphicData uri="http://schemas.openxmlformats.org/drawingml/2006/table">
            <a:tbl>
              <a:tblPr/>
              <a:tblGrid>
                <a:gridCol w="1925640"/>
                <a:gridCol w="927000"/>
                <a:gridCol w="1023840"/>
                <a:gridCol w="914400"/>
                <a:gridCol w="1219320"/>
              </a:tblGrid>
              <a:tr h="3502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MP1-caPTHR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MP1-Sos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MP1-caPTHR1; DMP1-Sos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68760" rIns="68760" tIns="0" bIns="0" anchor="b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spcBef>
                          <a:spcPts val="476"/>
                        </a:spcBef>
                        <a:tabLst>
                          <a:tab algn="l" pos="0"/>
                          <a:tab algn="l" pos="2286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alvaria thickness (</a:t>
                      </a: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μ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1.12</a:t>
                      </a: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1.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6.61</a:t>
                      </a: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.09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9.26</a:t>
                      </a: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.7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2.32</a:t>
                      </a: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1.32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#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5160">
                <a:tc>
                  <a:txBody>
                    <a:bodyPr lIns="68760" rIns="68760" tIns="0" bIns="0" anchor="b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spcAft>
                          <a:spcPts val="476"/>
                        </a:spcAft>
                        <a:tabLst>
                          <a:tab algn="l" pos="0"/>
                          <a:tab algn="l" pos="2286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eriosteal BFR/BS (µm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/µm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/d)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2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19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1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0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76"/>
                        </a:spcBef>
                        <a:spcAft>
                          <a:spcPts val="476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7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3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#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12" name="Text Box 13"/>
          <p:cNvSpPr/>
          <p:nvPr/>
        </p:nvSpPr>
        <p:spPr>
          <a:xfrm>
            <a:off x="309960" y="50338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3" name="Group 180"/>
          <p:cNvGrpSpPr/>
          <p:nvPr/>
        </p:nvGrpSpPr>
        <p:grpSpPr>
          <a:xfrm>
            <a:off x="1295280" y="866880"/>
            <a:ext cx="3621240" cy="1800000"/>
            <a:chOff x="1295280" y="866880"/>
            <a:chExt cx="3621240" cy="1800000"/>
          </a:xfrm>
        </p:grpSpPr>
        <p:sp>
          <p:nvSpPr>
            <p:cNvPr id="214" name="Text Box 2"/>
            <p:cNvSpPr/>
            <p:nvPr/>
          </p:nvSpPr>
          <p:spPr>
            <a:xfrm>
              <a:off x="1569240" y="2243880"/>
              <a:ext cx="1557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P1-caPTHR1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Text Box 3"/>
            <p:cNvSpPr/>
            <p:nvPr/>
          </p:nvSpPr>
          <p:spPr>
            <a:xfrm>
              <a:off x="2266920" y="1256040"/>
              <a:ext cx="858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Text Box 2"/>
            <p:cNvSpPr/>
            <p:nvPr/>
          </p:nvSpPr>
          <p:spPr>
            <a:xfrm>
              <a:off x="1295280" y="1751400"/>
              <a:ext cx="1830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l1a1-caPTHR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Rectangle 164"/>
            <p:cNvSpPr/>
            <p:nvPr/>
          </p:nvSpPr>
          <p:spPr>
            <a:xfrm>
              <a:off x="3116880" y="1203480"/>
              <a:ext cx="1526400" cy="146340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18" name="Picture 2" descr="E:\Bellido CAO calvaria\Calvaria images for measurement\24__rec0301.bmp"/>
            <p:cNvPicPr/>
            <p:nvPr/>
          </p:nvPicPr>
          <p:blipFill>
            <a:blip r:embed="rId1"/>
            <a:srcRect l="38226" t="60550" r="47181" b="31009"/>
            <a:stretch/>
          </p:blipFill>
          <p:spPr>
            <a:xfrm rot="10800000">
              <a:off x="3332880" y="1274040"/>
              <a:ext cx="1100160" cy="286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9" name="Picture 3" descr="E:\Bellido CAO calvaria\Calvaria images for measurement\8__rec0879.bmp"/>
            <p:cNvPicPr/>
            <p:nvPr/>
          </p:nvPicPr>
          <p:blipFill>
            <a:blip r:embed="rId2"/>
            <a:srcRect l="69313" t="38582" r="14723" b="52624"/>
            <a:stretch/>
          </p:blipFill>
          <p:spPr>
            <a:xfrm rot="11280600">
              <a:off x="3278880" y="2164680"/>
              <a:ext cx="1202040" cy="380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0" name="Picture 4" descr="E:\Bellido CAO calvaria\Calvaria images for measurement\25__rec0556.bmp"/>
            <p:cNvPicPr/>
            <p:nvPr/>
          </p:nvPicPr>
          <p:blipFill>
            <a:blip r:embed="rId3"/>
            <a:srcRect l="61437" t="54397" r="25846" b="35174"/>
            <a:stretch/>
          </p:blipFill>
          <p:spPr>
            <a:xfrm rot="11280000">
              <a:off x="3409200" y="1768320"/>
              <a:ext cx="962640" cy="312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1" name="Text Box 2"/>
            <p:cNvSpPr/>
            <p:nvPr/>
          </p:nvSpPr>
          <p:spPr>
            <a:xfrm>
              <a:off x="4060800" y="2417400"/>
              <a:ext cx="529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  <a:ea typeface="Arial"/>
                </a:rPr>
                <a:t>190 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Text Box 3"/>
            <p:cNvSpPr/>
            <p:nvPr/>
          </p:nvSpPr>
          <p:spPr>
            <a:xfrm>
              <a:off x="3966840" y="1497960"/>
              <a:ext cx="627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  <a:ea typeface="Arial"/>
                </a:rPr>
                <a:t>81 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Text Box 2"/>
            <p:cNvSpPr/>
            <p:nvPr/>
          </p:nvSpPr>
          <p:spPr>
            <a:xfrm>
              <a:off x="4061160" y="195984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  <a:ea typeface="Arial"/>
                </a:rPr>
                <a:t>73 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Straight Connector 178"/>
            <p:cNvSpPr/>
            <p:nvPr/>
          </p:nvSpPr>
          <p:spPr>
            <a:xfrm>
              <a:off x="3169800" y="2612160"/>
              <a:ext cx="347400" cy="144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Rectangle 179"/>
            <p:cNvSpPr/>
            <p:nvPr/>
          </p:nvSpPr>
          <p:spPr>
            <a:xfrm>
              <a:off x="2821320" y="866880"/>
              <a:ext cx="209520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8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lvarial  thickness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26" name="Text Box 5"/>
          <p:cNvSpPr/>
          <p:nvPr/>
        </p:nvSpPr>
        <p:spPr>
          <a:xfrm>
            <a:off x="2036160" y="8721720"/>
            <a:ext cx="278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1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5-21T16:50:48Z</dcterms:created>
  <dc:creator>rheey</dc:creator>
  <dc:description/>
  <dc:language>en-US</dc:language>
  <cp:lastModifiedBy>56910</cp:lastModifiedBy>
  <dcterms:modified xsi:type="dcterms:W3CDTF">2010-12-07T03:19:23Z</dcterms:modified>
  <cp:revision>1377</cp:revision>
  <dc:subject/>
  <dc:title>Figures for JBMR paper</dc:title>
</cp:coreProperties>
</file>